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9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E73"/>
    <a:srgbClr val="BFBFBF"/>
    <a:srgbClr val="8D8DFF"/>
    <a:srgbClr val="4FB6E9"/>
    <a:srgbClr val="9001D4"/>
    <a:srgbClr val="019E73"/>
    <a:srgbClr val="000080"/>
    <a:srgbClr val="C8D1E2"/>
    <a:srgbClr val="FFFFFF"/>
    <a:srgbClr val="90BF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–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2DE63D5-997A-4646-A377-4702673A728D}" styleName="Light Style 2 –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9C7853C-536D-4A76-A0AE-DD22124D55A5}" styleName="Themed Style 1 –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73" autoAdjust="0"/>
    <p:restoredTop sz="94384" autoAdjust="0"/>
  </p:normalViewPr>
  <p:slideViewPr>
    <p:cSldViewPr snapToGrid="0">
      <p:cViewPr varScale="1">
        <p:scale>
          <a:sx n="84" d="100"/>
          <a:sy n="84" d="100"/>
        </p:scale>
        <p:origin x="3848" y="184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E63D69F-7222-B14D-9E01-39F81D144C7F}" type="datetimeFigureOut">
              <a:rPr lang="en-ES" smtClean="0"/>
              <a:t>18/6/25</a:t>
            </a:fld>
            <a:endParaRPr lang="en-E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E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E3D8AD-4781-4F42-A424-48FC4D64EB44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07632653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AE3D8AD-4781-4F42-A424-48FC4D64EB44}" type="slidenum">
              <a:rPr lang="en-ES" smtClean="0"/>
              <a:t>1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979192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1768171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1828919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9334202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501351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9816048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7941971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31247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472942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15838796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4174889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 dirty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633917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4440C-1931-844E-8E1C-5C48591A4CD4}" type="datetimeFigureOut">
              <a:rPr lang="en-ES" smtClean="0"/>
              <a:t>18/6/25</a:t>
            </a:fld>
            <a:endParaRPr lang="en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2E7698-6084-F64E-B258-69D5634F729E}" type="slidenum">
              <a:rPr lang="en-ES" smtClean="0"/>
              <a:t>‹#›</a:t>
            </a:fld>
            <a:endParaRPr lang="en-ES"/>
          </a:p>
        </p:txBody>
      </p:sp>
    </p:spTree>
    <p:extLst>
      <p:ext uri="{BB962C8B-B14F-4D97-AF65-F5344CB8AC3E}">
        <p14:creationId xmlns:p14="http://schemas.microsoft.com/office/powerpoint/2010/main" val="20743689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88830DF1-C88C-2FD0-7C81-6B73C212F58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17433395"/>
              </p:ext>
            </p:extLst>
          </p:nvPr>
        </p:nvGraphicFramePr>
        <p:xfrm>
          <a:off x="234892" y="350133"/>
          <a:ext cx="6400800" cy="811140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406364">
                  <a:extLst>
                    <a:ext uri="{9D8B030D-6E8A-4147-A177-3AD203B41FA5}">
                      <a16:colId xmlns:a16="http://schemas.microsoft.com/office/drawing/2014/main" val="1433439992"/>
                    </a:ext>
                  </a:extLst>
                </a:gridCol>
                <a:gridCol w="1106913">
                  <a:extLst>
                    <a:ext uri="{9D8B030D-6E8A-4147-A177-3AD203B41FA5}">
                      <a16:colId xmlns:a16="http://schemas.microsoft.com/office/drawing/2014/main" val="259569641"/>
                    </a:ext>
                  </a:extLst>
                </a:gridCol>
                <a:gridCol w="1887523">
                  <a:extLst>
                    <a:ext uri="{9D8B030D-6E8A-4147-A177-3AD203B41FA5}">
                      <a16:colId xmlns:a16="http://schemas.microsoft.com/office/drawing/2014/main" val="3841129603"/>
                    </a:ext>
                  </a:extLst>
                </a:gridCol>
              </a:tblGrid>
              <a:tr h="314885">
                <a:tc gridSpan="3">
                  <a:txBody>
                    <a:bodyPr/>
                    <a:lstStyle/>
                    <a:p>
                      <a:pPr>
                        <a:spcBef>
                          <a:spcPts val="200"/>
                        </a:spcBef>
                      </a:pPr>
                      <a:r>
                        <a:rPr lang="en-GB" sz="120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3 Table </a:t>
                      </a:r>
                      <a:r>
                        <a:rPr lang="en-GB" sz="12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— Cryo-electron microscopy single-particle analysis.</a:t>
                      </a:r>
                    </a:p>
                  </a:txBody>
                  <a:tcPr marB="288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0842519"/>
                  </a:ext>
                </a:extLst>
              </a:tr>
              <a:tr h="7153157">
                <a:tc>
                  <a:txBody>
                    <a:bodyPr/>
                    <a:lstStyle/>
                    <a:p>
                      <a:pPr>
                        <a:spcBef>
                          <a:spcPts val="200"/>
                        </a:spcBef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icroscope / voltage (kV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nchrotron site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gnification (nominal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lectron dose (e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pixel/s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xposure time (s) / total dose per movie (e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–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Å</a:t>
                      </a:r>
                      <a:r>
                        <a:rPr lang="en-GB" sz="1100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amera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focus range /steps (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μm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ixel size (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pixel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ovies used (no.)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ymmetry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inal no. of particles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Map resolution (</a:t>
                      </a: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) at FSC 0.143 / 0.5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rocessing software</a:t>
                      </a:r>
                    </a:p>
                    <a:p>
                      <a:pPr>
                        <a:spcAft>
                          <a:spcPts val="200"/>
                        </a:spcAft>
                      </a:pPr>
                      <a:endParaRPr lang="en-GB" sz="11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p values max/min/average/stand. dev.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commended contour level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p size/dimensions (both a=b=c)/angles (α=β=</a:t>
                      </a:r>
                      <a:r>
                        <a:rPr lang="en-GB" sz="11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γ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Box dimensions (</a:t>
                      </a:r>
                      <a:r>
                        <a:rPr lang="en-GB" sz="11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esolution estimates (</a:t>
                      </a:r>
                      <a:r>
                        <a:rPr lang="en-GB" sz="11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Å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 (masked/unmasked):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   FSC half maps (0.143)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   FSC model (0.143; 0.5)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MRinger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core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ap-model fit (level 0.029) Q-score/atom inclusion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C (mask) / CC (volume) / CC (peaks)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No. of protomers/residues/atoms/solvents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   non-covalent ligands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Rmsd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from target values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   bonds/angles/chirality/planarity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verage B-factors (Å</a:t>
                      </a:r>
                      <a:r>
                        <a:rPr lang="en-GB" sz="1100" kern="1200" baseline="300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: protein/ligands/solvents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ll-atom contacts and geometry analysis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   Protein residues in/with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   favoured Ramachandran regions/outliers/all residues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    outlying rotamers/bonds/angles/chirality/planarity/Cβ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ll-atom clashes/</a:t>
                      </a:r>
                      <a:r>
                        <a:rPr lang="en-GB" sz="11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lashscore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GB" sz="11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olprobity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score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rotein residues in multiple conformations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MDB access code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DB access code</a:t>
                      </a:r>
                      <a:r>
                        <a:rPr lang="en-E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18000" marB="1800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Glacios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/ 200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LBA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50,000×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1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0 / 47.5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Falcon 4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-1.5 to -2.5/0.2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3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989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1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14,990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≥7.1 / ≥8.0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ryoSPARC</a:t>
                      </a:r>
                      <a:r>
                        <a:rPr lang="en-E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11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T="18000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Krios</a:t>
                      </a: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 / 300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ESRF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65,000×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7.2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4.8 / 60.0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Falcon 4i+SelectrisX filter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-0.8 to -2.0 / 0.2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0.73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18,729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1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312,476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2.81 / 3.16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i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CryoSPARC</a:t>
                      </a:r>
                      <a:r>
                        <a:rPr lang="en-GB" sz="1100" i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en-GB" sz="1100" i="1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DeepEMhancer</a:t>
                      </a:r>
                      <a:endParaRPr lang="en-GB" sz="1100" i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endParaRPr lang="en-GB" sz="1100" i="1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23 / -0.222 / 0.000 / 0.010 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29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33.6 / 320 / 90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3.7, 85.4, 110.2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 / 2.8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6; 2.8 / 2.6; 2.6 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99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68 / 0.986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8 / 0.87 / 0.80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 (chain A) / 845 / 7043 / 151 /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 Zn</a:t>
                      </a:r>
                      <a:r>
                        <a:rPr lang="en-GB" sz="1100" kern="1200" baseline="300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+</a:t>
                      </a: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, 1 GOL, 7 AZI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06 / 0.875 / 0.050 / 0.008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9.6 / 103.9 / 88.7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 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36 (97%)/ 0 / 859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1 (5.4%) / 0 / 0 / 0 / 0 / 0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26 / 9.3 / 2.2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6 (1.9%)</a:t>
                      </a: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MD-52972</a:t>
                      </a:r>
                      <a:endParaRPr lang="en-ES" sz="1100" kern="1200" dirty="0">
                        <a:solidFill>
                          <a:schemeClr val="dk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200"/>
                        </a:spcAft>
                      </a:pPr>
                      <a:r>
                        <a:rPr lang="en-GB" sz="11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QA6</a:t>
                      </a:r>
                      <a:r>
                        <a:rPr lang="en-ES" sz="11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ES" sz="1100" dirty="0">
                        <a:effectLst/>
                        <a:latin typeface="Times New Roman" panose="02020603050405020304" pitchFamily="18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18000" marB="0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9358492"/>
                  </a:ext>
                </a:extLst>
              </a:tr>
              <a:tr h="643367">
                <a:tc gridSpan="3">
                  <a:txBody>
                    <a:bodyPr/>
                    <a:lstStyle/>
                    <a:p>
                      <a:pPr marL="0" marR="0" indent="0" algn="just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bbreviations: AZI, </a:t>
                      </a:r>
                      <a:r>
                        <a:rPr lang="en-GB" sz="1200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zide</a:t>
                      </a: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(N</a:t>
                      </a:r>
                      <a:r>
                        <a:rPr lang="en-GB" sz="1200" kern="1200" baseline="300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⊖</a:t>
                      </a: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=N</a:t>
                      </a:r>
                      <a:r>
                        <a:rPr lang="en-GB" sz="1200" kern="1200" baseline="300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⊕</a:t>
                      </a: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=N</a:t>
                      </a:r>
                      <a:r>
                        <a:rPr lang="en-GB" sz="1200" kern="1200" baseline="300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⊖</a:t>
                      </a: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); GOL, glycerol (CH</a:t>
                      </a:r>
                      <a:r>
                        <a:rPr lang="en-GB" sz="1200" kern="1200" baseline="-250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H–CH(OH)-CH</a:t>
                      </a:r>
                      <a:r>
                        <a:rPr lang="en-GB" sz="1200" kern="1200" baseline="-250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OH). Validation against the </a:t>
                      </a:r>
                      <a:r>
                        <a:rPr lang="en-GB" sz="120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ryoSPARC</a:t>
                      </a: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raw map according to the wwPDB Deposition Service (https://deposit-1.wwpdb.org/deposition) and to the </a:t>
                      </a:r>
                      <a:r>
                        <a:rPr lang="en-GB" sz="1200" i="1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omprehensive Validation</a:t>
                      </a: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protocol within </a:t>
                      </a:r>
                      <a:r>
                        <a:rPr lang="en-GB" sz="1200" i="1" kern="1200" dirty="0" err="1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Phenix</a:t>
                      </a:r>
                      <a:r>
                        <a:rPr lang="en-GB" sz="1200" kern="1200" dirty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</a:t>
                      </a:r>
                      <a:r>
                        <a:rPr lang="en-ES" sz="1200" dirty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-GB" sz="12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7433755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874443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3076</TotalTime>
  <Words>484</Words>
  <Application>Microsoft Macintosh PowerPoint</Application>
  <PresentationFormat>A4 Paper (210x297 mm)</PresentationFormat>
  <Paragraphs>9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.X.Gomis-Rüth</dc:creator>
  <cp:lastModifiedBy>F.X.Gomis-Rüth</cp:lastModifiedBy>
  <cp:revision>406</cp:revision>
  <dcterms:created xsi:type="dcterms:W3CDTF">2024-01-16T16:15:53Z</dcterms:created>
  <dcterms:modified xsi:type="dcterms:W3CDTF">2025-06-18T09:54:43Z</dcterms:modified>
</cp:coreProperties>
</file>